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9"/>
  </p:notesMasterIdLst>
  <p:sldIdLst>
    <p:sldId id="313" r:id="rId2"/>
    <p:sldId id="266" r:id="rId3"/>
    <p:sldId id="304" r:id="rId4"/>
    <p:sldId id="301" r:id="rId5"/>
    <p:sldId id="312" r:id="rId6"/>
    <p:sldId id="296" r:id="rId7"/>
    <p:sldId id="309" r:id="rId8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22" autoAdjust="0"/>
    <p:restoredTop sz="92222" autoAdjust="0"/>
  </p:normalViewPr>
  <p:slideViewPr>
    <p:cSldViewPr snapToGrid="0">
      <p:cViewPr varScale="1">
        <p:scale>
          <a:sx n="102" d="100"/>
          <a:sy n="102" d="100"/>
        </p:scale>
        <p:origin x="2178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DF0B4B-7232-4931-95C2-8D35E2E9DC68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557D96-2FC2-45A0-813C-83DFE1A3E2F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76937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9557D96-2FC2-45A0-813C-83DFE1A3E2F4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8491038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9557D96-2FC2-45A0-813C-83DFE1A3E2F4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051167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9557D96-2FC2-45A0-813C-83DFE1A3E2F4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3533099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endParaRPr lang="en-GB" sz="1800" b="1" u="sng" dirty="0">
              <a:solidFill>
                <a:srgbClr val="00808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9557D96-2FC2-45A0-813C-83DFE1A3E2F4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9006110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9557D96-2FC2-45A0-813C-83DFE1A3E2F4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832888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7552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8364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3444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1111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192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98995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3465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1957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4604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104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0286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0AFDA9-773E-455A-AEEA-723AC7D01F3F}" type="datetimeFigureOut">
              <a:rPr lang="en-GB" smtClean="0"/>
              <a:t>05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68A77-7DAD-42EA-BB9F-04B2296D9B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7829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817B6924-3207-4F8E-29E5-B9260482A9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7391251"/>
              </p:ext>
            </p:extLst>
          </p:nvPr>
        </p:nvGraphicFramePr>
        <p:xfrm>
          <a:off x="616600" y="953125"/>
          <a:ext cx="6258641" cy="3291748"/>
        </p:xfrm>
        <a:graphic>
          <a:graphicData uri="http://schemas.openxmlformats.org/drawingml/2006/table">
            <a:tbl>
              <a:tblPr firstRow="1" firstCol="1" bandRow="1"/>
              <a:tblGrid>
                <a:gridCol w="2526650">
                  <a:extLst>
                    <a:ext uri="{9D8B030D-6E8A-4147-A177-3AD203B41FA5}">
                      <a16:colId xmlns:a16="http://schemas.microsoft.com/office/drawing/2014/main" val="588815262"/>
                    </a:ext>
                  </a:extLst>
                </a:gridCol>
                <a:gridCol w="1070174">
                  <a:extLst>
                    <a:ext uri="{9D8B030D-6E8A-4147-A177-3AD203B41FA5}">
                      <a16:colId xmlns:a16="http://schemas.microsoft.com/office/drawing/2014/main" val="3973884169"/>
                    </a:ext>
                  </a:extLst>
                </a:gridCol>
                <a:gridCol w="1152625">
                  <a:extLst>
                    <a:ext uri="{9D8B030D-6E8A-4147-A177-3AD203B41FA5}">
                      <a16:colId xmlns:a16="http://schemas.microsoft.com/office/drawing/2014/main" val="1240749412"/>
                    </a:ext>
                  </a:extLst>
                </a:gridCol>
                <a:gridCol w="1509192">
                  <a:extLst>
                    <a:ext uri="{9D8B030D-6E8A-4147-A177-3AD203B41FA5}">
                      <a16:colId xmlns:a16="http://schemas.microsoft.com/office/drawing/2014/main" val="2572770484"/>
                    </a:ext>
                  </a:extLst>
                </a:gridCol>
              </a:tblGrid>
              <a:tr h="453674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2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BA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roinsulin-LIPS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sulin-LIPS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3713372"/>
                  </a:ext>
                </a:extLst>
              </a:tr>
              <a:tr h="208127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ue positive*, n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8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9528868"/>
                  </a:ext>
                </a:extLst>
              </a:tr>
              <a:tr h="208127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alse negative*, n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9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7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5100995"/>
                  </a:ext>
                </a:extLst>
              </a:tr>
              <a:tr h="208127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ue negative, n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93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91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88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2191717"/>
                  </a:ext>
                </a:extLst>
              </a:tr>
              <a:tr h="208127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alse positive, n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5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5607694"/>
                  </a:ext>
                </a:extLst>
              </a:tr>
              <a:tr h="208127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ensitivity, % 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2.7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.2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7.4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9943722"/>
                  </a:ext>
                </a:extLst>
              </a:tr>
              <a:tr h="208127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pecificity, %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4.4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3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2.4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6625967"/>
                  </a:ext>
                </a:extLst>
              </a:tr>
              <a:tr h="39732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AA positive 5-year diabetes risk, </a:t>
                      </a: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 (95% CI)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9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4 to 11.8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.6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6.7 to 22.8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.9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6.1 to 22.4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8181721"/>
                  </a:ext>
                </a:extLst>
              </a:tr>
              <a:tr h="39732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AA negative 5-year diabetes risk, </a:t>
                      </a: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 (95% CI)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7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0.8 to 3.5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9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 to 3.6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1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.2 to 3.8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8231885"/>
                  </a:ext>
                </a:extLst>
              </a:tr>
              <a:tr h="39732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AA positive 20-year diabetes risk, % (95% CI)</a:t>
                      </a:r>
                      <a:endParaRPr lang="en-GB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2.1 to 37.5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0.2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7.8 to 64.1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9.8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7.1 to 64.1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2091292"/>
                  </a:ext>
                </a:extLst>
              </a:tr>
              <a:tr h="39732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AA negative 20-year diabetes risk, % (95% CI)</a:t>
                      </a:r>
                      <a:endParaRPr lang="en-GB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.3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8.2 to 15.4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.3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9.3 to 16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.6%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9.6 to 16.3)</a:t>
                      </a:r>
                    </a:p>
                  </a:txBody>
                  <a:tcPr marL="40531" marR="40531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9657678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D8BEA447-0FAD-A945-A426-C9C1DA7248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0875" y="386685"/>
            <a:ext cx="9104608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: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est characteristics in relatives who developed (n=91) or did not develop (n=528) clinical type 1 diabetes.</a:t>
            </a: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en-GB" altLang="en-US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fined by progression to diabetes </a:t>
            </a: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75843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BA27E7-B9A9-9CF2-9DED-B8CE157E9D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2481941" cy="564145"/>
          </a:xfrm>
        </p:spPr>
        <p:txBody>
          <a:bodyPr>
            <a:normAutofit/>
          </a:bodyPr>
          <a:lstStyle/>
          <a:p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</a:t>
            </a:r>
            <a:r>
              <a:rPr lang="en-GB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1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AB7B258-CE9E-8906-1E52-7C9106CB9D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766742"/>
              </p:ext>
            </p:extLst>
          </p:nvPr>
        </p:nvGraphicFramePr>
        <p:xfrm>
          <a:off x="172334" y="217714"/>
          <a:ext cx="7944957" cy="5551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6117986" imgH="4275028" progId="Prism9.Document">
                  <p:embed/>
                </p:oleObj>
              </mc:Choice>
              <mc:Fallback>
                <p:oleObj name="Prism 9" r:id="rId3" imgW="6117986" imgH="427502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2334" y="217714"/>
                        <a:ext cx="7944957" cy="5551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3A980A1-F8CC-DA5C-6184-7879E26234C1}"/>
              </a:ext>
            </a:extLst>
          </p:cNvPr>
          <p:cNvSpPr txBox="1"/>
          <p:nvPr/>
        </p:nvSpPr>
        <p:spPr>
          <a:xfrm>
            <a:off x="172335" y="5623604"/>
            <a:ext cx="940709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. </a:t>
            </a:r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</a:rPr>
              <a:t>Diabetes Free survival in the whole BOX cohort for those tested or not tested for IAA LIP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: Autoantibody negative relatives. (progressors were selectively over sampled). B: Single autoantibody positive relatives (including single IAA RBA positives and IAA- other antibody positive (blue text in table)). C: IAA RBA pos with at least one other autoantibody (all tested by LIPS). D: IAA RBA positive + multiple other autoantibody positive relatives (this includes IAA positive + at least 2 other autoantibodies and IAA negative + at least 2 other autoantibodies (blue text in table)). Red line - tested by LIPS; Black line - not tested for LIPS. Dotted lines represent 50% risk and 20 years follow-up. </a:t>
            </a:r>
          </a:p>
        </p:txBody>
      </p:sp>
    </p:spTree>
    <p:extLst>
      <p:ext uri="{BB962C8B-B14F-4D97-AF65-F5344CB8AC3E}">
        <p14:creationId xmlns:p14="http://schemas.microsoft.com/office/powerpoint/2010/main" val="30463864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2D6F47C-27DA-970C-D9C0-23569444A52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31168"/>
          <a:stretch/>
        </p:blipFill>
        <p:spPr>
          <a:xfrm>
            <a:off x="174170" y="564144"/>
            <a:ext cx="9589473" cy="3383741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BE846842-7884-FC75-B4A7-04A3652AA0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2481941" cy="564145"/>
          </a:xfrm>
        </p:spPr>
        <p:txBody>
          <a:bodyPr>
            <a:normAutofit/>
          </a:bodyPr>
          <a:lstStyle/>
          <a:p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</a:t>
            </a:r>
            <a:r>
              <a:rPr lang="en-GB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2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CB514CB-5F50-F0B9-4817-0DA0CAF5799C}"/>
              </a:ext>
            </a:extLst>
          </p:cNvPr>
          <p:cNvSpPr txBox="1"/>
          <p:nvPr/>
        </p:nvSpPr>
        <p:spPr>
          <a:xfrm>
            <a:off x="174170" y="4324290"/>
            <a:ext cx="800462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. 2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1600" u="sng" dirty="0">
                <a:latin typeface="Arial" panose="020B0604020202020204" pitchFamily="34" charset="0"/>
                <a:cs typeface="Arial" panose="020B0604020202020204" pitchFamily="34" charset="0"/>
              </a:rPr>
              <a:t>Luciferase tagged (pro) insulin constructs</a:t>
            </a:r>
          </a:p>
        </p:txBody>
      </p:sp>
    </p:spTree>
    <p:extLst>
      <p:ext uri="{BB962C8B-B14F-4D97-AF65-F5344CB8AC3E}">
        <p14:creationId xmlns:p14="http://schemas.microsoft.com/office/powerpoint/2010/main" val="33034496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0B6C0A8-9D9A-3520-7845-8FE03E7707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5924206"/>
              </p:ext>
            </p:extLst>
          </p:nvPr>
        </p:nvGraphicFramePr>
        <p:xfrm>
          <a:off x="251188" y="292909"/>
          <a:ext cx="6077983" cy="47897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504841" imgH="2762742" progId="Prism9.Document">
                  <p:embed/>
                </p:oleObj>
              </mc:Choice>
              <mc:Fallback>
                <p:oleObj name="Prism 9" r:id="rId3" imgW="3504841" imgH="2762742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0B6C0A8-9D9A-3520-7845-8FE03E7707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1188" y="292909"/>
                        <a:ext cx="6077983" cy="47897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AFEC033-DFC9-C567-415F-0A2AEB29109F}"/>
              </a:ext>
            </a:extLst>
          </p:cNvPr>
          <p:cNvSpPr txBox="1"/>
          <p:nvPr/>
        </p:nvSpPr>
        <p:spPr>
          <a:xfrm>
            <a:off x="0" y="5082623"/>
            <a:ext cx="975360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3. </a:t>
            </a:r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</a:rPr>
              <a:t>Age at sampling of relatives included in this study.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is included 361 parents and 258 siblings of the proband. We used histograms to identify age 24 years as the nadir/mid-point between the youngest parent and the oldest sibling, with 4 parents &lt;24 years old and 4 siblings &gt;=24 years old. The first available sample on entry to BOX wa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here available. Entry to BOX for relatives was at the time of proband’s diagnosis with diabetes. </a:t>
            </a:r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7A07F26F-0BCD-A215-E8D9-0A301FCBDF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2481941" cy="564145"/>
          </a:xfrm>
        </p:spPr>
        <p:txBody>
          <a:bodyPr>
            <a:normAutofit/>
          </a:bodyPr>
          <a:lstStyle/>
          <a:p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</a:t>
            </a:r>
            <a:r>
              <a:rPr lang="en-GB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3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43745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B7A8E437-03D8-012F-EE1E-DAC4E988EAAD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2481941" cy="5641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</a:t>
            </a:r>
            <a:r>
              <a:rPr lang="en-GB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4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29BB768-E774-36BF-4039-9A3C013DBA3B}"/>
              </a:ext>
            </a:extLst>
          </p:cNvPr>
          <p:cNvSpPr txBox="1"/>
          <p:nvPr/>
        </p:nvSpPr>
        <p:spPr>
          <a:xfrm>
            <a:off x="120777" y="5470524"/>
            <a:ext cx="9347073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: </a:t>
            </a:r>
            <a:r>
              <a:rPr lang="en-GB" sz="1200" u="sng" dirty="0">
                <a:latin typeface="Arial" panose="020B0604020202020204" pitchFamily="34" charset="0"/>
                <a:cs typeface="Arial" panose="020B0604020202020204" pitchFamily="34" charset="0"/>
              </a:rPr>
              <a:t>(P)IAA levels in individuals with different diabetes status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lot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Nlu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PIAA against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Nlu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IAA levels in 267 schoolchildren and 150 people with new-onset type 1 diabetes. Spearman’s rank correlation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Nlu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PIAA with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Nlu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IAA was r=0.178 (p=0.003) in schoolchildren, r=0.941 (p&lt;0.001) in people with new-onset type 1 diabetes, r=0.799 (p&lt;0.001) in first-degree relatives who did progress to diabetes and 0.364 (p&lt;0.001) in relatives who did not progress to diabetes. 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D5A2314E-8723-3691-F1BA-46991CEF34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6536341"/>
              </p:ext>
            </p:extLst>
          </p:nvPr>
        </p:nvGraphicFramePr>
        <p:xfrm>
          <a:off x="120777" y="0"/>
          <a:ext cx="6189977" cy="5535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307057" imgH="5641093" progId="Prism9.Document">
                  <p:embed/>
                </p:oleObj>
              </mc:Choice>
              <mc:Fallback>
                <p:oleObj name="Prism 9" r:id="rId2" imgW="6307057" imgH="56410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0777" y="0"/>
                        <a:ext cx="6189977" cy="5535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308973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E755C1DF-1A76-6715-D91D-00CB46A739C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2481941" cy="5641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</a:t>
            </a:r>
            <a:r>
              <a:rPr lang="en-GB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5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E0B6232-7EF6-3AD2-A7E9-902F49618545}"/>
              </a:ext>
            </a:extLst>
          </p:cNvPr>
          <p:cNvSpPr txBox="1"/>
          <p:nvPr/>
        </p:nvSpPr>
        <p:spPr>
          <a:xfrm>
            <a:off x="0" y="4161711"/>
            <a:ext cx="976811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5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u="sng" dirty="0">
                <a:latin typeface="Arial" panose="020B0604020202020204" pitchFamily="34" charset="0"/>
                <a:cs typeface="Arial" panose="020B0604020202020204" pitchFamily="34" charset="0"/>
              </a:rPr>
              <a:t>ROC curve analysis of people with diabetes and schoolchildren without diabetes.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ceiver Operator Characteristic (ROC) curves (a &amp; b on different scales) and IAA positivity based on lab-defined thresholds (c). In 150 people with type 1 diabetes and 267 healthy schoolchildren. Grey – RBA, dark blue – LIPS-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ProIn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light blue – LIPS-Ins. A:Grey shaded area pAUC95. The pAUC95 was 0.028 (0.018-0.036), 0.038 (0.033-0.042), and 0.035 (0.028-0.041), respectively (RBA vs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Nlu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proinsulin p=0.031, RBA vs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Nlu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insulin p=0.168). 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4BEA8CF-B5C2-1CE0-EE6C-F081B7472E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9354167"/>
              </p:ext>
            </p:extLst>
          </p:nvPr>
        </p:nvGraphicFramePr>
        <p:xfrm>
          <a:off x="1" y="282073"/>
          <a:ext cx="9163050" cy="39625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6497569" imgH="2809922" progId="Prism9.Document">
                  <p:embed/>
                </p:oleObj>
              </mc:Choice>
              <mc:Fallback>
                <p:oleObj name="Prism 9" r:id="rId3" imgW="6497569" imgH="28099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" y="282073"/>
                        <a:ext cx="9163050" cy="39625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390101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271BCA-D231-CB71-4A63-53B77891A84D}"/>
              </a:ext>
            </a:extLst>
          </p:cNvPr>
          <p:cNvSpPr txBox="1">
            <a:spLocks/>
          </p:cNvSpPr>
          <p:nvPr/>
        </p:nvSpPr>
        <p:spPr>
          <a:xfrm>
            <a:off x="0" y="-106680"/>
            <a:ext cx="2481941" cy="5641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</a:t>
            </a:r>
            <a:r>
              <a:rPr lang="en-GB" sz="16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6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D28B911-6998-C864-E20D-8A923B16D733}"/>
              </a:ext>
            </a:extLst>
          </p:cNvPr>
          <p:cNvSpPr txBox="1"/>
          <p:nvPr/>
        </p:nvSpPr>
        <p:spPr>
          <a:xfrm>
            <a:off x="6057900" y="245746"/>
            <a:ext cx="3683434" cy="54476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</a:t>
            </a:r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</a:rPr>
              <a:t>ROC curve analysis of relatives of people with diabetes. 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: ROC curve for relatives under 24 years old at sampling. B: Percentage of relatives under 24 years at sampling positive for IAA with each method. C: ROC curve for relatives over 24 years old at sampling. D: Percentage of relatives over 24 years old at sampling, positive for IAA with each method. Grey – RBA, dark blue –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roIn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light blue – Ins. A:Grey shaded area pAUC95. Under 24, pAUC95 for RBA 0.004 (95%CI 0-0.013), fo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roIn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IPS 0.017 (95%CI 0.006-0.031), for Ins LIPS 0.014 (95%CI 0.006-0.027), p=0.029 (Ins LIPS vs RBA). Over 24, pAUC95 for RBA 0.002 (95%CI 0-0.004), fo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roIn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0.005 (95% CI 0.002-0.009), for Ins LIPS 0.005 (95% 0.002-0.009), p=0.072 (Ins LIPS vs RBA). Diabetes is self-reported. In the group sampled over 24 years old only 8 of 66 progressors reported type 1 diabetes, however of those who reported a different diabetes diagnosis 9 had evidence of islet autoantibodies before diabetes diagnosis (2 had multiple islet autoantibodies (1 with and 1 without IAA), 5 had IAA by RBA + 1 other islet autoantibody, and 2 had 1 autoantibody (not IAA). 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687983D-8322-E2F0-473B-7261CBC76F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5818173"/>
              </p:ext>
            </p:extLst>
          </p:nvPr>
        </p:nvGraphicFramePr>
        <p:xfrm>
          <a:off x="-60961" y="245746"/>
          <a:ext cx="6433186" cy="64587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5999141" imgH="6022496" progId="Prism9.Document">
                  <p:embed/>
                </p:oleObj>
              </mc:Choice>
              <mc:Fallback>
                <p:oleObj name="Prism 9" r:id="rId3" imgW="5999141" imgH="602249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60961" y="245746"/>
                        <a:ext cx="6433186" cy="64587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61581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7</TotalTime>
  <Words>941</Words>
  <Application>Microsoft Office PowerPoint</Application>
  <PresentationFormat>A4 Paper (210x297 mm)</PresentationFormat>
  <Paragraphs>81</Paragraphs>
  <Slides>7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Supplementary Fig. 1</vt:lpstr>
      <vt:lpstr>Supplementary Fig. 2</vt:lpstr>
      <vt:lpstr>Supplementary Fig. 3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Long</dc:creator>
  <cp:lastModifiedBy>Anna Long</cp:lastModifiedBy>
  <cp:revision>41</cp:revision>
  <dcterms:created xsi:type="dcterms:W3CDTF">2023-03-02T09:24:11Z</dcterms:created>
  <dcterms:modified xsi:type="dcterms:W3CDTF">2025-11-05T17:26:13Z</dcterms:modified>
</cp:coreProperties>
</file>